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5" d="100"/>
          <a:sy n="95" d="100"/>
        </p:scale>
        <p:origin x="-2316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B5FC6-98DA-4A54-A7C0-4FD3644C87A2}" type="datetimeFigureOut">
              <a:rPr lang="en-GB" smtClean="0"/>
              <a:t>18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3C939-CFD9-44A1-BB2C-4E1E8D02D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9109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B5FC6-98DA-4A54-A7C0-4FD3644C87A2}" type="datetimeFigureOut">
              <a:rPr lang="en-GB" smtClean="0"/>
              <a:t>18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3C939-CFD9-44A1-BB2C-4E1E8D02D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0913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B5FC6-98DA-4A54-A7C0-4FD3644C87A2}" type="datetimeFigureOut">
              <a:rPr lang="en-GB" smtClean="0"/>
              <a:t>18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3C939-CFD9-44A1-BB2C-4E1E8D02D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7258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B5FC6-98DA-4A54-A7C0-4FD3644C87A2}" type="datetimeFigureOut">
              <a:rPr lang="en-GB" smtClean="0"/>
              <a:t>18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3C939-CFD9-44A1-BB2C-4E1E8D02D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8695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B5FC6-98DA-4A54-A7C0-4FD3644C87A2}" type="datetimeFigureOut">
              <a:rPr lang="en-GB" smtClean="0"/>
              <a:t>18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3C939-CFD9-44A1-BB2C-4E1E8D02D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7689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B5FC6-98DA-4A54-A7C0-4FD3644C87A2}" type="datetimeFigureOut">
              <a:rPr lang="en-GB" smtClean="0"/>
              <a:t>18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3C939-CFD9-44A1-BB2C-4E1E8D02D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4623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B5FC6-98DA-4A54-A7C0-4FD3644C87A2}" type="datetimeFigureOut">
              <a:rPr lang="en-GB" smtClean="0"/>
              <a:t>18/03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3C939-CFD9-44A1-BB2C-4E1E8D02D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16472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B5FC6-98DA-4A54-A7C0-4FD3644C87A2}" type="datetimeFigureOut">
              <a:rPr lang="en-GB" smtClean="0"/>
              <a:t>18/03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3C939-CFD9-44A1-BB2C-4E1E8D02D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4384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B5FC6-98DA-4A54-A7C0-4FD3644C87A2}" type="datetimeFigureOut">
              <a:rPr lang="en-GB" smtClean="0"/>
              <a:t>18/03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3C939-CFD9-44A1-BB2C-4E1E8D02D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0829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B5FC6-98DA-4A54-A7C0-4FD3644C87A2}" type="datetimeFigureOut">
              <a:rPr lang="en-GB" smtClean="0"/>
              <a:t>18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3C939-CFD9-44A1-BB2C-4E1E8D02D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840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B5FC6-98DA-4A54-A7C0-4FD3644C87A2}" type="datetimeFigureOut">
              <a:rPr lang="en-GB" smtClean="0"/>
              <a:t>18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83C939-CFD9-44A1-BB2C-4E1E8D02D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04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3B5FC6-98DA-4A54-A7C0-4FD3644C87A2}" type="datetimeFigureOut">
              <a:rPr lang="en-GB" smtClean="0"/>
              <a:t>18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83C939-CFD9-44A1-BB2C-4E1E8D02D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07310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5994"/>
            <a:ext cx="3356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476672" y="3707904"/>
            <a:ext cx="568863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Flow cytometric analysis of FLAG intracellular expression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OVAS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ells were transfected with an empty vector control plasmid or FLAG tag Rgs1 plasmid and 48 hours later, intracellular staining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sing an anti-FLAG-FITC antibody was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erformed. The grey curve represents the empty vector control and the green curve represents the fluorescent intensity of the FLAG-FITC positive population. The population of Rgs1 transfected cells was 72 % FLAG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ositiv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t this time point. </a:t>
            </a:r>
          </a:p>
        </p:txBody>
      </p:sp>
      <p:pic>
        <p:nvPicPr>
          <p:cNvPr id="7169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21" b="13503"/>
          <a:stretch>
            <a:fillRect/>
          </a:stretch>
        </p:blipFill>
        <p:spPr bwMode="auto">
          <a:xfrm>
            <a:off x="1781679" y="926049"/>
            <a:ext cx="2165701" cy="23472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 Box 6"/>
          <p:cNvSpPr txBox="1">
            <a:spLocks noChangeArrowheads="1"/>
          </p:cNvSpPr>
          <p:nvPr/>
        </p:nvSpPr>
        <p:spPr bwMode="auto">
          <a:xfrm rot="-5400000">
            <a:off x="1119144" y="1856540"/>
            <a:ext cx="111512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% of Max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 Box 7"/>
          <p:cNvSpPr txBox="1">
            <a:spLocks noChangeArrowheads="1"/>
          </p:cNvSpPr>
          <p:nvPr/>
        </p:nvSpPr>
        <p:spPr bwMode="auto">
          <a:xfrm>
            <a:off x="2196876" y="3261390"/>
            <a:ext cx="175050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400" dirty="0">
                <a:effectLst/>
                <a:latin typeface="Times New Roman"/>
                <a:ea typeface="Calibri"/>
              </a:rPr>
              <a:t>FLAG-FITC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3927933" y="1255075"/>
            <a:ext cx="1869352" cy="395586"/>
            <a:chOff x="0" y="0"/>
            <a:chExt cx="1869743" cy="395785"/>
          </a:xfrm>
        </p:grpSpPr>
        <p:sp>
          <p:nvSpPr>
            <p:cNvPr id="13" name="Text Box 2"/>
            <p:cNvSpPr txBox="1">
              <a:spLocks noChangeArrowheads="1"/>
            </p:cNvSpPr>
            <p:nvPr/>
          </p:nvSpPr>
          <p:spPr bwMode="auto">
            <a:xfrm>
              <a:off x="116006" y="0"/>
              <a:ext cx="1753737" cy="395785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GB" sz="1000" dirty="0">
                  <a:effectLst/>
                  <a:latin typeface="Times New Roman"/>
                  <a:ea typeface="Calibri"/>
                </a:rPr>
                <a:t>RGS1-FLAG transfected cells</a:t>
              </a:r>
              <a:endParaRPr lang="en-GB" sz="1200" dirty="0">
                <a:effectLst/>
                <a:latin typeface="Times New Roman"/>
                <a:ea typeface="Calibri"/>
              </a:endParaRPr>
            </a:p>
            <a:p>
              <a:pPr>
                <a:spcAft>
                  <a:spcPts val="0"/>
                </a:spcAft>
              </a:pPr>
              <a:r>
                <a:rPr lang="en-GB" sz="1000" dirty="0">
                  <a:effectLst/>
                  <a:latin typeface="Times New Roman"/>
                  <a:ea typeface="Calibri"/>
                </a:rPr>
                <a:t>Empty vector transfected cells</a:t>
              </a:r>
              <a:endParaRPr lang="en-GB" sz="1200" dirty="0">
                <a:effectLst/>
                <a:latin typeface="Times New Roman"/>
                <a:ea typeface="Calibri"/>
              </a:endParaRPr>
            </a:p>
          </p:txBody>
        </p:sp>
        <p:cxnSp>
          <p:nvCxnSpPr>
            <p:cNvPr id="14" name="Straight Connector 13"/>
            <p:cNvCxnSpPr/>
            <p:nvPr/>
          </p:nvCxnSpPr>
          <p:spPr>
            <a:xfrm>
              <a:off x="0" y="129654"/>
              <a:ext cx="184150" cy="0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0" y="259307"/>
              <a:ext cx="184150" cy="0"/>
            </a:xfrm>
            <a:prstGeom prst="line">
              <a:avLst/>
            </a:prstGeom>
            <a:ln w="28575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Rectangle 1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6" name="Rectangle 16"/>
          <p:cNvSpPr>
            <a:spLocks noChangeArrowheads="1"/>
          </p:cNvSpPr>
          <p:nvPr/>
        </p:nvSpPr>
        <p:spPr bwMode="auto">
          <a:xfrm>
            <a:off x="0" y="4572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7" name="Rectangle 17"/>
          <p:cNvSpPr>
            <a:spLocks noChangeArrowheads="1"/>
          </p:cNvSpPr>
          <p:nvPr/>
        </p:nvSpPr>
        <p:spPr bwMode="auto">
          <a:xfrm>
            <a:off x="0" y="2181225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8149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3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yoti Patel</dc:creator>
  <cp:lastModifiedBy>Jyoti Patel</cp:lastModifiedBy>
  <cp:revision>2</cp:revision>
  <dcterms:created xsi:type="dcterms:W3CDTF">2018-03-16T17:21:26Z</dcterms:created>
  <dcterms:modified xsi:type="dcterms:W3CDTF">2018-03-18T17:17:52Z</dcterms:modified>
</cp:coreProperties>
</file>